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906000" cy="6858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29" y="57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9094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227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4267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538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7256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07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5715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633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2474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569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138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FBE4E-86D9-4D2F-BF01-B1300F87228B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87D88-2842-4BAE-B265-8F7D2C8294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605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xmlns="" id="{0F2F4B7F-6914-8CCC-CF4E-0940C429B1C6}"/>
              </a:ext>
            </a:extLst>
          </p:cNvPr>
          <p:cNvCxnSpPr/>
          <p:nvPr/>
        </p:nvCxnSpPr>
        <p:spPr>
          <a:xfrm>
            <a:off x="1228634" y="1784778"/>
            <a:ext cx="0" cy="271338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xmlns="" id="{CFD32DF6-26AA-924C-612B-D710AD10A66D}"/>
              </a:ext>
            </a:extLst>
          </p:cNvPr>
          <p:cNvCxnSpPr/>
          <p:nvPr/>
        </p:nvCxnSpPr>
        <p:spPr>
          <a:xfrm>
            <a:off x="1377722" y="1754961"/>
            <a:ext cx="0" cy="272332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692798AE-9029-A749-B2D3-F34055668328}"/>
              </a:ext>
            </a:extLst>
          </p:cNvPr>
          <p:cNvSpPr txBox="1"/>
          <p:nvPr/>
        </p:nvSpPr>
        <p:spPr>
          <a:xfrm>
            <a:off x="181246" y="2407414"/>
            <a:ext cx="9143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GEM</a:t>
            </a:r>
          </a:p>
          <a:p>
            <a:r>
              <a:rPr kumimoji="1" lang="en-US" altLang="ja-JP" dirty="0"/>
              <a:t>(</a:t>
            </a:r>
            <a:r>
              <a:rPr kumimoji="1" lang="en-US" altLang="ja-JP" dirty="0" err="1"/>
              <a:t>dFdC</a:t>
            </a:r>
            <a:r>
              <a:rPr kumimoji="1" lang="en-US" altLang="ja-JP" dirty="0"/>
              <a:t>)</a:t>
            </a:r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C4406493-5FDB-C0BA-CD52-A50FD13D5465}"/>
              </a:ext>
            </a:extLst>
          </p:cNvPr>
          <p:cNvSpPr txBox="1"/>
          <p:nvPr/>
        </p:nvSpPr>
        <p:spPr>
          <a:xfrm>
            <a:off x="1795169" y="2446523"/>
            <a:ext cx="675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FdC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E7507929-C287-564E-0203-7A97841B1A69}"/>
              </a:ext>
            </a:extLst>
          </p:cNvPr>
          <p:cNvSpPr txBox="1"/>
          <p:nvPr/>
        </p:nvSpPr>
        <p:spPr>
          <a:xfrm>
            <a:off x="3304479" y="2446523"/>
            <a:ext cx="1023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FdCMP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5F294B42-35AC-D230-ED84-2EF21A7BAEB7}"/>
              </a:ext>
            </a:extLst>
          </p:cNvPr>
          <p:cNvSpPr txBox="1"/>
          <p:nvPr/>
        </p:nvSpPr>
        <p:spPr>
          <a:xfrm>
            <a:off x="5312198" y="2462872"/>
            <a:ext cx="993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FdCDP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CA97C158-E4AB-DC8C-597B-1547F2564197}"/>
              </a:ext>
            </a:extLst>
          </p:cNvPr>
          <p:cNvSpPr txBox="1"/>
          <p:nvPr/>
        </p:nvSpPr>
        <p:spPr>
          <a:xfrm>
            <a:off x="7140997" y="2446523"/>
            <a:ext cx="993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FdCTP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634DEE96-FD59-777B-84EB-2E1A16CF5D19}"/>
              </a:ext>
            </a:extLst>
          </p:cNvPr>
          <p:cNvSpPr txBox="1"/>
          <p:nvPr/>
        </p:nvSpPr>
        <p:spPr>
          <a:xfrm>
            <a:off x="1805103" y="3623518"/>
            <a:ext cx="675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FdU</a:t>
            </a:r>
            <a:endParaRPr kumimoji="1"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46EDBD48-A361-C8A4-865D-C054D14E9511}"/>
              </a:ext>
            </a:extLst>
          </p:cNvPr>
          <p:cNvSpPr txBox="1"/>
          <p:nvPr/>
        </p:nvSpPr>
        <p:spPr>
          <a:xfrm>
            <a:off x="3374060" y="3623518"/>
            <a:ext cx="1023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FdUMP</a:t>
            </a:r>
            <a:endParaRPr kumimoji="1" lang="ja-JP" altLang="en-US" dirty="0"/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xmlns="" id="{B265A576-6DB6-FB27-D35B-F0A481F1224F}"/>
              </a:ext>
            </a:extLst>
          </p:cNvPr>
          <p:cNvCxnSpPr>
            <a:cxnSpLocks/>
          </p:cNvCxnSpPr>
          <p:nvPr/>
        </p:nvCxnSpPr>
        <p:spPr>
          <a:xfrm>
            <a:off x="903514" y="2647538"/>
            <a:ext cx="74254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xmlns="" id="{326F77EA-24A9-7115-A16B-3905DACA846C}"/>
              </a:ext>
            </a:extLst>
          </p:cNvPr>
          <p:cNvCxnSpPr/>
          <p:nvPr/>
        </p:nvCxnSpPr>
        <p:spPr>
          <a:xfrm>
            <a:off x="2480961" y="2592079"/>
            <a:ext cx="8348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xmlns="" id="{45E72876-718A-8BD0-2DC2-4D6838EA2F46}"/>
              </a:ext>
            </a:extLst>
          </p:cNvPr>
          <p:cNvCxnSpPr/>
          <p:nvPr/>
        </p:nvCxnSpPr>
        <p:spPr>
          <a:xfrm flipH="1">
            <a:off x="2480961" y="2730579"/>
            <a:ext cx="7951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xmlns="" id="{4CC6ECEA-8CA7-431A-9E48-BAC790CEA533}"/>
              </a:ext>
            </a:extLst>
          </p:cNvPr>
          <p:cNvCxnSpPr/>
          <p:nvPr/>
        </p:nvCxnSpPr>
        <p:spPr>
          <a:xfrm>
            <a:off x="4358034" y="2642713"/>
            <a:ext cx="88458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xmlns="" id="{7FB0C032-B91F-19EF-81D3-79BBD26883C0}"/>
              </a:ext>
            </a:extLst>
          </p:cNvPr>
          <p:cNvCxnSpPr>
            <a:cxnSpLocks/>
          </p:cNvCxnSpPr>
          <p:nvPr/>
        </p:nvCxnSpPr>
        <p:spPr>
          <a:xfrm>
            <a:off x="6256411" y="2647538"/>
            <a:ext cx="79512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xmlns="" id="{3D0AA6D3-1500-4B60-15E3-E769B6CF756D}"/>
              </a:ext>
            </a:extLst>
          </p:cNvPr>
          <p:cNvCxnSpPr>
            <a:stCxn id="6" idx="2"/>
            <a:endCxn id="10" idx="0"/>
          </p:cNvCxnSpPr>
          <p:nvPr/>
        </p:nvCxnSpPr>
        <p:spPr>
          <a:xfrm>
            <a:off x="2133098" y="2815855"/>
            <a:ext cx="9934" cy="8076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xmlns="" id="{CD90A7AF-63A2-A493-D232-B19F034E0A56}"/>
              </a:ext>
            </a:extLst>
          </p:cNvPr>
          <p:cNvCxnSpPr>
            <a:stCxn id="7" idx="2"/>
          </p:cNvCxnSpPr>
          <p:nvPr/>
        </p:nvCxnSpPr>
        <p:spPr>
          <a:xfrm>
            <a:off x="3816344" y="2815855"/>
            <a:ext cx="0" cy="7605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xmlns="" id="{F57E4182-F1B8-78F7-0EE2-C2E86A20DAA6}"/>
              </a:ext>
            </a:extLst>
          </p:cNvPr>
          <p:cNvCxnSpPr>
            <a:cxnSpLocks/>
          </p:cNvCxnSpPr>
          <p:nvPr/>
        </p:nvCxnSpPr>
        <p:spPr>
          <a:xfrm>
            <a:off x="2570412" y="3758489"/>
            <a:ext cx="7951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xmlns="" id="{0F19E0F5-F902-E130-100F-6FD5EFE4568D}"/>
              </a:ext>
            </a:extLst>
          </p:cNvPr>
          <p:cNvCxnSpPr/>
          <p:nvPr/>
        </p:nvCxnSpPr>
        <p:spPr>
          <a:xfrm flipH="1">
            <a:off x="2540600" y="3923277"/>
            <a:ext cx="80506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xmlns="" id="{1292CECF-3425-21F6-9AFE-759426F4DF05}"/>
              </a:ext>
            </a:extLst>
          </p:cNvPr>
          <p:cNvCxnSpPr>
            <a:cxnSpLocks/>
          </p:cNvCxnSpPr>
          <p:nvPr/>
        </p:nvCxnSpPr>
        <p:spPr>
          <a:xfrm flipH="1">
            <a:off x="903514" y="3823888"/>
            <a:ext cx="74254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B14DA1AC-36A5-0C10-4EB6-71B2ADF88FC4}"/>
              </a:ext>
            </a:extLst>
          </p:cNvPr>
          <p:cNvSpPr txBox="1"/>
          <p:nvPr/>
        </p:nvSpPr>
        <p:spPr>
          <a:xfrm>
            <a:off x="1029842" y="1948238"/>
            <a:ext cx="6957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ENT1</a:t>
            </a:r>
          </a:p>
          <a:p>
            <a:r>
              <a:rPr lang="en-US" altLang="ja-JP" dirty="0"/>
              <a:t>ENT2</a:t>
            </a:r>
            <a:endParaRPr kumimoji="1" lang="ja-JP" altLang="en-US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FA2D856F-563E-0BDF-DE21-CEBEB3B19C79}"/>
              </a:ext>
            </a:extLst>
          </p:cNvPr>
          <p:cNvSpPr txBox="1"/>
          <p:nvPr/>
        </p:nvSpPr>
        <p:spPr>
          <a:xfrm>
            <a:off x="2600237" y="2120537"/>
            <a:ext cx="675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CK</a:t>
            </a:r>
            <a:endParaRPr kumimoji="1" lang="ja-JP" altLang="en-US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1E0AFFCA-5275-2FE0-1174-65B6749156F0}"/>
              </a:ext>
            </a:extLst>
          </p:cNvPr>
          <p:cNvSpPr txBox="1"/>
          <p:nvPr/>
        </p:nvSpPr>
        <p:spPr>
          <a:xfrm>
            <a:off x="4358026" y="2278206"/>
            <a:ext cx="9342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CMPK</a:t>
            </a:r>
            <a:endParaRPr kumimoji="1" lang="ja-JP" altLang="en-US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31204533-DEF5-E102-7929-985B88FF331A}"/>
              </a:ext>
            </a:extLst>
          </p:cNvPr>
          <p:cNvSpPr txBox="1"/>
          <p:nvPr/>
        </p:nvSpPr>
        <p:spPr>
          <a:xfrm>
            <a:off x="6266336" y="2273381"/>
            <a:ext cx="785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NDPK</a:t>
            </a:r>
            <a:endParaRPr kumimoji="1" lang="ja-JP" altLang="en-US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CEA0C38C-A1A8-575D-2A33-AAD9385C76DD}"/>
              </a:ext>
            </a:extLst>
          </p:cNvPr>
          <p:cNvSpPr txBox="1"/>
          <p:nvPr/>
        </p:nvSpPr>
        <p:spPr>
          <a:xfrm>
            <a:off x="2548063" y="2845386"/>
            <a:ext cx="847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5’-NT</a:t>
            </a:r>
            <a:endParaRPr kumimoji="1" lang="ja-JP" altLang="en-US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FC990D93-25C6-B8D0-F255-13A70FC0E2ED}"/>
              </a:ext>
            </a:extLst>
          </p:cNvPr>
          <p:cNvSpPr txBox="1"/>
          <p:nvPr/>
        </p:nvSpPr>
        <p:spPr>
          <a:xfrm>
            <a:off x="1447303" y="3000521"/>
            <a:ext cx="7504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CDA</a:t>
            </a:r>
            <a:endParaRPr kumimoji="1" lang="ja-JP" altLang="en-US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72A1A515-9D39-D08C-1F97-7F90451979FA}"/>
              </a:ext>
            </a:extLst>
          </p:cNvPr>
          <p:cNvSpPr txBox="1"/>
          <p:nvPr/>
        </p:nvSpPr>
        <p:spPr>
          <a:xfrm>
            <a:off x="3885925" y="2920147"/>
            <a:ext cx="1245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dCMP</a:t>
            </a:r>
            <a:endParaRPr kumimoji="1" lang="en-US" altLang="ja-JP" dirty="0"/>
          </a:p>
          <a:p>
            <a:r>
              <a:rPr lang="en-US" altLang="ja-JP" dirty="0"/>
              <a:t>deaminase</a:t>
            </a:r>
            <a:endParaRPr kumimoji="1" lang="ja-JP" altLang="en-US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7C9F48AA-E379-846F-2E5C-7FD846B5A74D}"/>
              </a:ext>
            </a:extLst>
          </p:cNvPr>
          <p:cNvSpPr txBox="1"/>
          <p:nvPr/>
        </p:nvSpPr>
        <p:spPr>
          <a:xfrm>
            <a:off x="7190682" y="1219245"/>
            <a:ext cx="13119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TP-synthetase</a:t>
            </a:r>
            <a:endParaRPr kumimoji="1" lang="ja-JP" altLang="en-US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7FD8EDAD-2D97-5E6A-5B55-B7AC8B201939}"/>
              </a:ext>
            </a:extLst>
          </p:cNvPr>
          <p:cNvSpPr txBox="1"/>
          <p:nvPr/>
        </p:nvSpPr>
        <p:spPr>
          <a:xfrm>
            <a:off x="5486582" y="1475590"/>
            <a:ext cx="535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RR</a:t>
            </a:r>
            <a:endParaRPr kumimoji="1" lang="ja-JP" altLang="en-US" dirty="0"/>
          </a:p>
        </p:txBody>
      </p: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xmlns="" id="{16AAAD89-90A7-CE68-D8CE-65B2C650F34D}"/>
              </a:ext>
            </a:extLst>
          </p:cNvPr>
          <p:cNvGrpSpPr/>
          <p:nvPr/>
        </p:nvGrpSpPr>
        <p:grpSpPr>
          <a:xfrm>
            <a:off x="7369591" y="1964801"/>
            <a:ext cx="367741" cy="493246"/>
            <a:chOff x="8229601" y="2197666"/>
            <a:chExt cx="367741" cy="493246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xmlns="" id="{B5A22CC4-188B-1569-0A7A-13BAF1919FA2}"/>
                </a:ext>
              </a:extLst>
            </p:cNvPr>
            <p:cNvCxnSpPr>
              <a:cxnSpLocks/>
            </p:cNvCxnSpPr>
            <p:nvPr/>
          </p:nvCxnSpPr>
          <p:spPr>
            <a:xfrm>
              <a:off x="8413471" y="2197666"/>
              <a:ext cx="4972" cy="49324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xmlns="" id="{AE1AF300-54A3-7D0A-9F59-F57EF537C515}"/>
                </a:ext>
              </a:extLst>
            </p:cNvPr>
            <p:cNvCxnSpPr/>
            <p:nvPr/>
          </p:nvCxnSpPr>
          <p:spPr>
            <a:xfrm>
              <a:off x="8229601" y="2197666"/>
              <a:ext cx="36774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xmlns="" id="{552259F3-1BD6-B197-7D6E-C42334184504}"/>
              </a:ext>
            </a:extLst>
          </p:cNvPr>
          <p:cNvCxnSpPr>
            <a:cxnSpLocks/>
          </p:cNvCxnSpPr>
          <p:nvPr/>
        </p:nvCxnSpPr>
        <p:spPr>
          <a:xfrm>
            <a:off x="5698161" y="1948238"/>
            <a:ext cx="4972" cy="49324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xmlns="" id="{6C211900-83DD-89D7-1F52-C7E85D3E5649}"/>
              </a:ext>
            </a:extLst>
          </p:cNvPr>
          <p:cNvCxnSpPr/>
          <p:nvPr/>
        </p:nvCxnSpPr>
        <p:spPr>
          <a:xfrm>
            <a:off x="5514291" y="1948238"/>
            <a:ext cx="36774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xmlns="" id="{5A174C35-1B88-FA1F-3968-B32C2BB3CEE4}"/>
              </a:ext>
            </a:extLst>
          </p:cNvPr>
          <p:cNvGrpSpPr/>
          <p:nvPr/>
        </p:nvGrpSpPr>
        <p:grpSpPr>
          <a:xfrm rot="15695909">
            <a:off x="6113818" y="1893985"/>
            <a:ext cx="384965" cy="2387769"/>
            <a:chOff x="8430742" y="2339448"/>
            <a:chExt cx="288352" cy="499748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xmlns="" id="{1F74C62C-41F1-D9AA-37CB-369F98F6E6D4}"/>
                </a:ext>
              </a:extLst>
            </p:cNvPr>
            <p:cNvCxnSpPr>
              <a:cxnSpLocks/>
            </p:cNvCxnSpPr>
            <p:nvPr/>
          </p:nvCxnSpPr>
          <p:spPr>
            <a:xfrm>
              <a:off x="8568047" y="2345950"/>
              <a:ext cx="4972" cy="49324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xmlns="" id="{251DDAD5-45A8-7622-132D-E88B94E870C5}"/>
                </a:ext>
              </a:extLst>
            </p:cNvPr>
            <p:cNvCxnSpPr>
              <a:cxnSpLocks/>
            </p:cNvCxnSpPr>
            <p:nvPr/>
          </p:nvCxnSpPr>
          <p:spPr>
            <a:xfrm rot="6146081" flipH="1" flipV="1">
              <a:off x="8568493" y="2201697"/>
              <a:ext cx="12849" cy="28835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48AC2003-787E-0F7D-D4B3-C8310DA1F717}"/>
              </a:ext>
            </a:extLst>
          </p:cNvPr>
          <p:cNvSpPr txBox="1"/>
          <p:nvPr/>
        </p:nvSpPr>
        <p:spPr>
          <a:xfrm>
            <a:off x="5580943" y="3629293"/>
            <a:ext cx="1479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TS</a:t>
            </a:r>
            <a:endParaRPr kumimoji="1" lang="ja-JP" altLang="en-US" dirty="0"/>
          </a:p>
        </p:txBody>
      </p: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xmlns="" id="{C28AC235-94F3-9D96-F3A6-CF0C7D81AFF9}"/>
              </a:ext>
            </a:extLst>
          </p:cNvPr>
          <p:cNvGrpSpPr/>
          <p:nvPr/>
        </p:nvGrpSpPr>
        <p:grpSpPr>
          <a:xfrm rot="5400000">
            <a:off x="4772171" y="3265639"/>
            <a:ext cx="367741" cy="1116498"/>
            <a:chOff x="8229601" y="2197666"/>
            <a:chExt cx="367741" cy="493246"/>
          </a:xfrm>
        </p:grpSpPr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xmlns="" id="{BEFF062C-92C8-8C29-2B78-1E3C49D27BF1}"/>
                </a:ext>
              </a:extLst>
            </p:cNvPr>
            <p:cNvCxnSpPr>
              <a:cxnSpLocks/>
            </p:cNvCxnSpPr>
            <p:nvPr/>
          </p:nvCxnSpPr>
          <p:spPr>
            <a:xfrm>
              <a:off x="8413471" y="2197666"/>
              <a:ext cx="4972" cy="49324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xmlns="" id="{4A20A1AD-AE62-A5AF-B1B4-300322C1E18D}"/>
                </a:ext>
              </a:extLst>
            </p:cNvPr>
            <p:cNvCxnSpPr/>
            <p:nvPr/>
          </p:nvCxnSpPr>
          <p:spPr>
            <a:xfrm>
              <a:off x="8229601" y="2197666"/>
              <a:ext cx="36774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3E0269BA-76B7-148E-3E86-245D1B33B22E}"/>
              </a:ext>
            </a:extLst>
          </p:cNvPr>
          <p:cNvSpPr txBox="1"/>
          <p:nvPr/>
        </p:nvSpPr>
        <p:spPr>
          <a:xfrm>
            <a:off x="1377715" y="4808250"/>
            <a:ext cx="7577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Figure S-1: </a:t>
            </a:r>
            <a:r>
              <a:rPr kumimoji="1" lang="en-US" altLang="ja-JP" dirty="0"/>
              <a:t>Intracellular metabolic pathway of GEM and its associated enzyme</a:t>
            </a:r>
            <a:endParaRPr kumimoji="1" lang="ja-JP" altLang="en-US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7BCCC0B6-41AA-A3DF-6484-F7766CF8DF78}"/>
              </a:ext>
            </a:extLst>
          </p:cNvPr>
          <p:cNvSpPr txBox="1"/>
          <p:nvPr/>
        </p:nvSpPr>
        <p:spPr>
          <a:xfrm>
            <a:off x="4129833" y="807819"/>
            <a:ext cx="3117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ndirect inhibition of synthesis</a:t>
            </a:r>
            <a:endParaRPr kumimoji="1" lang="ja-JP" altLang="en-US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AAB2AC9E-2EE8-719F-91BC-E2D2D23F65A2}"/>
              </a:ext>
            </a:extLst>
          </p:cNvPr>
          <p:cNvSpPr txBox="1"/>
          <p:nvPr/>
        </p:nvSpPr>
        <p:spPr>
          <a:xfrm>
            <a:off x="8354903" y="2199531"/>
            <a:ext cx="131195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direct inhibition of synthesis</a:t>
            </a:r>
            <a:endParaRPr kumimoji="1" lang="ja-JP" altLang="en-US" dirty="0"/>
          </a:p>
        </p:txBody>
      </p:sp>
      <p:sp>
        <p:nvSpPr>
          <p:cNvPr id="47" name="矢印: 右 46">
            <a:extLst>
              <a:ext uri="{FF2B5EF4-FFF2-40B4-BE49-F238E27FC236}">
                <a16:creationId xmlns:a16="http://schemas.microsoft.com/office/drawing/2014/main" xmlns="" id="{B877A47F-3A2F-2C61-7EDA-6F740486C6FE}"/>
              </a:ext>
            </a:extLst>
          </p:cNvPr>
          <p:cNvSpPr/>
          <p:nvPr/>
        </p:nvSpPr>
        <p:spPr>
          <a:xfrm rot="16200000">
            <a:off x="5568123" y="1139309"/>
            <a:ext cx="240422" cy="331984"/>
          </a:xfrm>
          <a:prstGeom prst="rightArrow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8" name="矢印: 右 47">
            <a:extLst>
              <a:ext uri="{FF2B5EF4-FFF2-40B4-BE49-F238E27FC236}">
                <a16:creationId xmlns:a16="http://schemas.microsoft.com/office/drawing/2014/main" xmlns="" id="{5E98BC0F-8452-7615-DBBF-AAB931824F24}"/>
              </a:ext>
            </a:extLst>
          </p:cNvPr>
          <p:cNvSpPr/>
          <p:nvPr/>
        </p:nvSpPr>
        <p:spPr>
          <a:xfrm>
            <a:off x="8060354" y="2446371"/>
            <a:ext cx="240422" cy="331984"/>
          </a:xfrm>
          <a:prstGeom prst="rightArrow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43757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1</TotalTime>
  <Words>44</Words>
  <Application>Microsoft Office PowerPoint</Application>
  <PresentationFormat>A4 210 x 297 mm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郡司 真理子</dc:creator>
  <cp:lastModifiedBy>本田 一穂</cp:lastModifiedBy>
  <cp:revision>61</cp:revision>
  <cp:lastPrinted>2022-10-27T06:50:15Z</cp:lastPrinted>
  <dcterms:created xsi:type="dcterms:W3CDTF">2022-06-18T21:25:56Z</dcterms:created>
  <dcterms:modified xsi:type="dcterms:W3CDTF">2022-12-16T02:37:33Z</dcterms:modified>
</cp:coreProperties>
</file>